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6"/>
  </p:normalViewPr>
  <p:slideViewPr>
    <p:cSldViewPr snapToGrid="0" snapToObjects="1">
      <p:cViewPr varScale="1">
        <p:scale>
          <a:sx n="112" d="100"/>
          <a:sy n="112" d="100"/>
        </p:scale>
        <p:origin x="5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8F76D3-174E-5245-A876-ECC1DA1E5B7E}" type="datetimeFigureOut">
              <a:rPr lang="en-US" smtClean="0"/>
              <a:t>2/24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9E94DA-B83E-7E4D-9619-5B5825EB0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894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PK"/>
              <a:t>There is another</a:t>
            </a:r>
            <a:r>
              <a:rPr lang="en-US" dirty="0"/>
              <a:t> very nice</a:t>
            </a:r>
            <a:r>
              <a:rPr lang="en-PK"/>
              <a:t> feature that </a:t>
            </a:r>
            <a:r>
              <a:rPr lang="en-GB" dirty="0"/>
              <a:t>I</a:t>
            </a:r>
            <a:r>
              <a:rPr lang="en-PK"/>
              <a:t> would like to introduce about IVIS is computed tomography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4BAE6E-6DD3-F544-8A0C-7E759439990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8161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483D4-8348-2044-A198-F9F7FA6DE1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BB79CA-B2CF-9E4B-9F39-C755F7E301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E6E3F-97EC-6F4D-A46F-B1969B649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09900-B523-3043-845F-4708FBFCA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CBE51C-FBA2-E94C-948D-A13620A91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072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10999-02FD-6E45-8F98-3F297360E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87BFE6-3A29-514D-B7D6-58E8949589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D47E62-F4BE-7C47-A66B-08CD0701D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47DB0-4A92-1F4B-BAD2-B01D1328A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37F7C-D8F0-0849-8C3C-6589DB56E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4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4BAD8F-A1DC-2146-A56C-0D7CE9268E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BFD5E1-1764-7E47-BEE4-A796D526E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124A22-02AC-474E-99FE-E76A7827E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9B8071-CF09-7749-846F-A6AF43C21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504C23-0AF0-9843-AE19-D9C414126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454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7AA4E-F705-0649-8F81-5DB5387B8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BBDE0B-15D7-9A44-BFCE-963C6A61B4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A3EED3-B547-B347-9419-CCF39D5DF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8FB5B7-06D8-1545-A41D-350EFFAC5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05040-8905-E540-9609-80E559342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164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6CCB52-F0BA-B949-A5C4-46E35DFCE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2AE609-15AE-554D-AA27-8FBEC49881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E62AC9-8AFD-C247-B291-5FC0A0408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BBBCF5-DDD8-9D44-862F-24C98667B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B5F25A-EBE5-6C48-B032-C4562EC56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421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61229-BC03-BC48-A787-E9A8F62BA2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7D206D-CF80-E949-84E0-4C94B1EF97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7C5C8A-9FA5-814F-9787-3F7DEC4C8E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8954DF-92A8-D840-9293-708CC2185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B868A3-4BE3-BC4D-B0CC-D0A1A99C1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0D6398-8913-6349-BBE1-1AFB393D6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907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B7CC3-BE8D-AC40-B1FA-08666E98E1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9FD9D8-56AF-B04F-8489-EB7685354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595C62-27A9-9948-8CFC-2CE03C5E8C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60F032-3E96-3D48-A7E0-3A94296115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5DDA31-AC3E-744C-9FDB-1CBEE2BB04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BB8EAD-B0A0-7447-BD4F-E9E918028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20A703-3645-2548-825E-24C47856C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2727D4-414D-5E49-B5B4-0B2CABF36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540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61830-C9B1-AD47-A2B4-161D95866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82E9BB-8DA7-6F4E-B4F8-D05063479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7CC300-6C95-8B4B-835B-D87B05ED1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D0C20C-DD01-5147-B13D-EE18F5138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479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7B6830-BBC7-1A4F-906E-48CA6A5A1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F9010A-9BE0-F849-AADE-CECF96646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AB9CD9-303F-D544-BA67-D377FD3D3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190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DBCCE-27C4-0F47-AD61-CB8C5D556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B681CE-A355-8F4A-A46F-F137AF9013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36BA2B-50B5-1F4F-87D5-6E5483CAA6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92145A-8D35-CE4F-A9E5-639BCAA83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41568D-F60A-454C-9DCD-81469B266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CB4FA7-5042-F840-B5C8-64C84A356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652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96114-A978-BD49-AB5E-C20178962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938FD8-B351-BC47-A1CF-E99B3462E1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4DBCF3-8801-EC41-805D-772B73E4F7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08D911-02F2-2C49-BBA8-AA8071FA5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242D02-E79B-A647-8EED-EB791AF5F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8692C1-53D4-5B4C-A019-FD3C7B895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451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878ECB-DC8F-4248-9C8F-2A36C8DE1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161553-374D-6948-AF63-90FF128880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40DBFA-FAFC-C54B-97AB-446A403A52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34DFC-5C6C-D54E-8F90-7179583D69E2}" type="datetimeFigureOut">
              <a:rPr lang="en-US" smtClean="0"/>
              <a:t>2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62DA81-9F3C-4F44-83EA-C4D16B6FC4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E15807-C4D8-0B45-BA5E-771085DB1D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51CAC-CB54-EF48-9F45-F92148B48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270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C3F65B-02CD-F749-B8F2-80521FF381A6}"/>
              </a:ext>
            </a:extLst>
          </p:cNvPr>
          <p:cNvSpPr txBox="1"/>
          <p:nvPr/>
        </p:nvSpPr>
        <p:spPr>
          <a:xfrm>
            <a:off x="1194262" y="5635626"/>
            <a:ext cx="90673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Computed Tomography (CT-Scan) in IVIS imaging</a:t>
            </a:r>
            <a:r>
              <a:rPr lang="en-PK"/>
              <a:t> </a:t>
            </a:r>
            <a:r>
              <a:rPr lang="en-PK" dirty="0"/>
              <a:t>provides 3D tissue localization of the fluorescent agent signal with anatomical context. </a:t>
            </a:r>
          </a:p>
        </p:txBody>
      </p:sp>
      <p:pic>
        <p:nvPicPr>
          <p:cNvPr id="4" name="WhatsApp Video 2024-11-12 at 4.06.29 PM.mp4" descr="WhatsApp Video 2024-11-12 at 4.06.29 PM.mp4">
            <a:hlinkClick r:id="" action="ppaction://media"/>
            <a:extLst>
              <a:ext uri="{FF2B5EF4-FFF2-40B4-BE49-F238E27FC236}">
                <a16:creationId xmlns:a16="http://schemas.microsoft.com/office/drawing/2014/main" id="{DB10AF0D-8F77-8E44-8CB4-4F034A5879B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43467" y="1658132"/>
            <a:ext cx="5294716" cy="3240149"/>
          </a:xfrm>
          <a:prstGeom prst="rect">
            <a:avLst/>
          </a:prstGeom>
        </p:spPr>
      </p:pic>
      <p:pic>
        <p:nvPicPr>
          <p:cNvPr id="5" name="WhatsApp Video 2024-11-12 at 4.16.29 PM.mp4" descr="WhatsApp Video 2024-11-12 at 4.16.29 PM.mp4">
            <a:hlinkClick r:id="" action="ppaction://media"/>
            <a:extLst>
              <a:ext uri="{FF2B5EF4-FFF2-40B4-BE49-F238E27FC236}">
                <a16:creationId xmlns:a16="http://schemas.microsoft.com/office/drawing/2014/main" id="{80756DED-F8F5-804D-87C3-C059699F52D8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6373088" y="1613681"/>
            <a:ext cx="4738862" cy="3329050"/>
          </a:xfrm>
          <a:prstGeom prst="rect">
            <a:avLst/>
          </a:prstGeom>
        </p:spPr>
      </p:pic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940C66-383C-DE4B-ABF3-2798A9A4F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A98-9994-C041-A45B-4C8B340D2AA5}" type="slidenum">
              <a:rPr lang="en-US" smtClean="0"/>
              <a:t>1</a:t>
            </a:fld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525020E-5ACF-9344-929F-CD2CD4CDA9D2}"/>
              </a:ext>
            </a:extLst>
          </p:cNvPr>
          <p:cNvSpPr txBox="1"/>
          <p:nvPr/>
        </p:nvSpPr>
        <p:spPr>
          <a:xfrm>
            <a:off x="643467" y="391377"/>
            <a:ext cx="28002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ementary Video S1</a:t>
            </a:r>
          </a:p>
        </p:txBody>
      </p:sp>
    </p:spTree>
    <p:extLst>
      <p:ext uri="{BB962C8B-B14F-4D97-AF65-F5344CB8AC3E}">
        <p14:creationId xmlns:p14="http://schemas.microsoft.com/office/powerpoint/2010/main" val="38629294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96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9792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4</Words>
  <Application>Microsoft Macintosh PowerPoint</Application>
  <PresentationFormat>Widescreen</PresentationFormat>
  <Paragraphs>5</Paragraphs>
  <Slides>1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shad Padhiar</dc:creator>
  <cp:lastModifiedBy>Arshad Padhiar</cp:lastModifiedBy>
  <cp:revision>2</cp:revision>
  <dcterms:created xsi:type="dcterms:W3CDTF">2026-02-24T11:19:54Z</dcterms:created>
  <dcterms:modified xsi:type="dcterms:W3CDTF">2026-02-24T11:30:21Z</dcterms:modified>
</cp:coreProperties>
</file>